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6" d="100"/>
          <a:sy n="86" d="100"/>
        </p:scale>
        <p:origin x="292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E$96:$E$102</c:f>
                <c:numCache>
                  <c:formatCode>General</c:formatCode>
                  <c:ptCount val="7"/>
                  <c:pt idx="0">
                    <c:v>13.158212555556341</c:v>
                  </c:pt>
                  <c:pt idx="1">
                    <c:v>70.489358307808928</c:v>
                  </c:pt>
                  <c:pt idx="2">
                    <c:v>67.057215168913331</c:v>
                  </c:pt>
                  <c:pt idx="3">
                    <c:v>18.623414256985583</c:v>
                  </c:pt>
                  <c:pt idx="4">
                    <c:v>93.232578729917918</c:v>
                  </c:pt>
                  <c:pt idx="5">
                    <c:v>1.5337690425474295</c:v>
                  </c:pt>
                  <c:pt idx="6">
                    <c:v>8.054686976395876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C$96:$C$101</c:f>
              <c:strCache>
                <c:ptCount val="6"/>
                <c:pt idx="0">
                  <c:v>EV</c:v>
                </c:pt>
                <c:pt idx="1">
                  <c:v>ETOH</c:v>
                </c:pt>
                <c:pt idx="2">
                  <c:v>p65</c:v>
                </c:pt>
                <c:pt idx="3">
                  <c:v>c-Myc</c:v>
                </c:pt>
                <c:pt idx="4">
                  <c:v>c-Fos</c:v>
                </c:pt>
                <c:pt idx="5">
                  <c:v>c-Jun</c:v>
                </c:pt>
              </c:strCache>
            </c:strRef>
          </c:cat>
          <c:val>
            <c:numRef>
              <c:f>Sheet1!$D$96:$D$101</c:f>
              <c:numCache>
                <c:formatCode>General</c:formatCode>
                <c:ptCount val="6"/>
                <c:pt idx="0">
                  <c:v>100</c:v>
                </c:pt>
                <c:pt idx="1">
                  <c:v>430.95357064493925</c:v>
                </c:pt>
                <c:pt idx="2">
                  <c:v>407.97481869254784</c:v>
                </c:pt>
                <c:pt idx="3">
                  <c:v>232.76010886654237</c:v>
                </c:pt>
                <c:pt idx="4">
                  <c:v>502.79023987118046</c:v>
                </c:pt>
                <c:pt idx="5">
                  <c:v>145.673243389904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287-4C48-B5A9-1D4766FD929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-65385648"/>
        <c:axId val="-65379120"/>
      </c:barChart>
      <c:catAx>
        <c:axId val="-653856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65379120"/>
        <c:crosses val="autoZero"/>
        <c:auto val="1"/>
        <c:lblAlgn val="ctr"/>
        <c:lblOffset val="100"/>
        <c:noMultiLvlLbl val="0"/>
      </c:catAx>
      <c:valAx>
        <c:axId val="-65379120"/>
        <c:scaling>
          <c:orientation val="minMax"/>
          <c:max val="6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653856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C$147</c:f>
              <c:strCache>
                <c:ptCount val="1"/>
                <c:pt idx="0">
                  <c:v>StarD10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D$148:$D$153</c:f>
                <c:numCache>
                  <c:formatCode>General</c:formatCode>
                  <c:ptCount val="6"/>
                  <c:pt idx="0">
                    <c:v>0.13</c:v>
                  </c:pt>
                  <c:pt idx="1">
                    <c:v>0.28999999999999998</c:v>
                  </c:pt>
                  <c:pt idx="2">
                    <c:v>0.37</c:v>
                  </c:pt>
                  <c:pt idx="3">
                    <c:v>0.03</c:v>
                  </c:pt>
                  <c:pt idx="4">
                    <c:v>0.17</c:v>
                  </c:pt>
                  <c:pt idx="5">
                    <c:v>4.4999999999999998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B$148:$B$153</c:f>
              <c:strCache>
                <c:ptCount val="6"/>
                <c:pt idx="0">
                  <c:v>EV</c:v>
                </c:pt>
                <c:pt idx="1">
                  <c:v>EtOH</c:v>
                </c:pt>
                <c:pt idx="2">
                  <c:v>p65</c:v>
                </c:pt>
                <c:pt idx="3">
                  <c:v>c-Myc</c:v>
                </c:pt>
                <c:pt idx="4">
                  <c:v>c-Fos</c:v>
                </c:pt>
                <c:pt idx="5">
                  <c:v>c-Jun</c:v>
                </c:pt>
              </c:strCache>
            </c:strRef>
          </c:cat>
          <c:val>
            <c:numRef>
              <c:f>Sheet1!$C$148:$C$153</c:f>
              <c:numCache>
                <c:formatCode>General</c:formatCode>
                <c:ptCount val="6"/>
                <c:pt idx="0">
                  <c:v>1</c:v>
                </c:pt>
                <c:pt idx="1">
                  <c:v>2.0099999999999998</c:v>
                </c:pt>
                <c:pt idx="2">
                  <c:v>1.99</c:v>
                </c:pt>
                <c:pt idx="3">
                  <c:v>2.29</c:v>
                </c:pt>
                <c:pt idx="4">
                  <c:v>1.31</c:v>
                </c:pt>
                <c:pt idx="5">
                  <c:v>0.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66E-46F3-9C48-A230C7737E3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-65381296"/>
        <c:axId val="-65374768"/>
      </c:barChart>
      <c:catAx>
        <c:axId val="-653812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65374768"/>
        <c:crosses val="autoZero"/>
        <c:auto val="1"/>
        <c:lblAlgn val="ctr"/>
        <c:lblOffset val="100"/>
        <c:noMultiLvlLbl val="0"/>
      </c:catAx>
      <c:valAx>
        <c:axId val="-65374768"/>
        <c:scaling>
          <c:orientation val="minMax"/>
        </c:scaling>
        <c:delete val="0"/>
        <c:axPos val="l"/>
        <c:numFmt formatCode="#,##0.0" sourceLinked="0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6538129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B9412-6402-49E0-B1B3-2EE813C35BAF}" type="datetimeFigureOut">
              <a:rPr lang="en-US" smtClean="0"/>
              <a:t>10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69736-A76A-461A-AE45-DF93A82515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45653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B9412-6402-49E0-B1B3-2EE813C35BAF}" type="datetimeFigureOut">
              <a:rPr lang="en-US" smtClean="0"/>
              <a:t>10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69736-A76A-461A-AE45-DF93A82515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70605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B9412-6402-49E0-B1B3-2EE813C35BAF}" type="datetimeFigureOut">
              <a:rPr lang="en-US" smtClean="0"/>
              <a:t>10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69736-A76A-461A-AE45-DF93A82515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63901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B9412-6402-49E0-B1B3-2EE813C35BAF}" type="datetimeFigureOut">
              <a:rPr lang="en-US" smtClean="0"/>
              <a:t>10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69736-A76A-461A-AE45-DF93A82515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5841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B9412-6402-49E0-B1B3-2EE813C35BAF}" type="datetimeFigureOut">
              <a:rPr lang="en-US" smtClean="0"/>
              <a:t>10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69736-A76A-461A-AE45-DF93A82515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8047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B9412-6402-49E0-B1B3-2EE813C35BAF}" type="datetimeFigureOut">
              <a:rPr lang="en-US" smtClean="0"/>
              <a:t>10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69736-A76A-461A-AE45-DF93A82515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06304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B9412-6402-49E0-B1B3-2EE813C35BAF}" type="datetimeFigureOut">
              <a:rPr lang="en-US" smtClean="0"/>
              <a:t>10/12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69736-A76A-461A-AE45-DF93A82515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13474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B9412-6402-49E0-B1B3-2EE813C35BAF}" type="datetimeFigureOut">
              <a:rPr lang="en-US" smtClean="0"/>
              <a:t>10/12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69736-A76A-461A-AE45-DF93A82515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37324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B9412-6402-49E0-B1B3-2EE813C35BAF}" type="datetimeFigureOut">
              <a:rPr lang="en-US" smtClean="0"/>
              <a:t>10/12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69736-A76A-461A-AE45-DF93A82515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2142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B9412-6402-49E0-B1B3-2EE813C35BAF}" type="datetimeFigureOut">
              <a:rPr lang="en-US" smtClean="0"/>
              <a:t>10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69736-A76A-461A-AE45-DF93A82515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72886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B9412-6402-49E0-B1B3-2EE813C35BAF}" type="datetimeFigureOut">
              <a:rPr lang="en-US" smtClean="0"/>
              <a:t>10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69736-A76A-461A-AE45-DF93A82515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91916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DB9412-6402-49E0-B1B3-2EE813C35BAF}" type="datetimeFigureOut">
              <a:rPr lang="en-US" smtClean="0"/>
              <a:t>10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369736-A76A-461A-AE45-DF93A82515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80597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2.xml"/><Relationship Id="rId5" Type="http://schemas.openxmlformats.org/officeDocument/2006/relationships/image" Target="../media/image2.tiff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2">
            <a:extLst>
              <a:ext uri="{FF2B5EF4-FFF2-40B4-BE49-F238E27FC236}">
                <a16:creationId xmlns:a16="http://schemas.microsoft.com/office/drawing/2014/main" id="{4A944B23-7919-4A95-B082-B5CBD0025F7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02977" y="8749568"/>
            <a:ext cx="3030220" cy="4781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2        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700F208E-8600-497B-8E8D-196A0F0FA3A2}"/>
              </a:ext>
            </a:extLst>
          </p:cNvPr>
          <p:cNvGrpSpPr/>
          <p:nvPr/>
        </p:nvGrpSpPr>
        <p:grpSpPr>
          <a:xfrm>
            <a:off x="341767" y="4492158"/>
            <a:ext cx="2916880" cy="2555656"/>
            <a:chOff x="39824" y="570708"/>
            <a:chExt cx="4585044" cy="3378199"/>
          </a:xfrm>
        </p:grpSpPr>
        <p:graphicFrame>
          <p:nvGraphicFramePr>
            <p:cNvPr id="8" name="Chart 7">
              <a:extLst>
                <a:ext uri="{FF2B5EF4-FFF2-40B4-BE49-F238E27FC236}">
                  <a16:creationId xmlns:a16="http://schemas.microsoft.com/office/drawing/2014/main" id="{93C712A2-0308-4CF7-9008-C296682300B4}"/>
                </a:ext>
              </a:extLst>
            </p:cNvPr>
            <p:cNvGraphicFramePr>
              <a:graphicFrameLocks/>
            </p:cNvGraphicFramePr>
            <p:nvPr>
              <p:extLst/>
            </p:nvPr>
          </p:nvGraphicFramePr>
          <p:xfrm>
            <a:off x="663807" y="1216272"/>
            <a:ext cx="3961061" cy="273263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9" name="TextBox 2">
              <a:extLst>
                <a:ext uri="{FF2B5EF4-FFF2-40B4-BE49-F238E27FC236}">
                  <a16:creationId xmlns:a16="http://schemas.microsoft.com/office/drawing/2014/main" id="{93E201C9-1763-4996-9362-46C0E93FA55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-1419675" y="2030207"/>
              <a:ext cx="3378199" cy="4592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noAutofit/>
            </a:bodyPr>
            <a:lstStyle/>
            <a:p>
              <a:pPr algn="ctr" fontAlgn="base"/>
              <a:r>
                <a:rPr lang="en-US" sz="1200" b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% of </a:t>
              </a:r>
              <a:r>
                <a:rPr lang="en-US" sz="1200" b="1" i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STARD10</a:t>
              </a:r>
              <a:r>
                <a:rPr lang="en-US" sz="1200" b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 promoter activity</a:t>
              </a:r>
              <a:endPara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  <a:p>
              <a:pPr algn="ctr" fontAlgn="base"/>
              <a:r>
                <a:rPr lang="en-US" sz="1200" b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(relative to EV)</a:t>
              </a:r>
              <a:endPara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2">
              <a:extLst>
                <a:ext uri="{FF2B5EF4-FFF2-40B4-BE49-F238E27FC236}">
                  <a16:creationId xmlns:a16="http://schemas.microsoft.com/office/drawing/2014/main" id="{D57C7F91-39F2-4B82-8584-8A1BDF958D4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882790" y="1414967"/>
              <a:ext cx="521869" cy="371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anchor="ctr" anchorCtr="0">
              <a:noAutofit/>
            </a:bodyPr>
            <a:lstStyle/>
            <a:p>
              <a:pPr algn="ctr" fontAlgn="base"/>
              <a:r>
                <a:rPr lang="en-US" b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*</a:t>
              </a:r>
              <a:endParaRPr lang="en-US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2">
              <a:extLst>
                <a:ext uri="{FF2B5EF4-FFF2-40B4-BE49-F238E27FC236}">
                  <a16:creationId xmlns:a16="http://schemas.microsoft.com/office/drawing/2014/main" id="{D744D419-BC70-4A70-97C8-9A122A93E8F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384385" y="1511117"/>
              <a:ext cx="521869" cy="371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anchor="ctr" anchorCtr="0">
              <a:noAutofit/>
            </a:bodyPr>
            <a:lstStyle/>
            <a:p>
              <a:pPr algn="ctr" fontAlgn="base"/>
              <a:r>
                <a:rPr lang="en-US" b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*</a:t>
              </a:r>
              <a:endParaRPr lang="en-US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2">
              <a:extLst>
                <a:ext uri="{FF2B5EF4-FFF2-40B4-BE49-F238E27FC236}">
                  <a16:creationId xmlns:a16="http://schemas.microsoft.com/office/drawing/2014/main" id="{B01FE878-C428-4AFE-B849-B7DD97A50B4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886508" y="2184134"/>
              <a:ext cx="521869" cy="371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anchor="ctr" anchorCtr="0">
              <a:noAutofit/>
            </a:bodyPr>
            <a:lstStyle/>
            <a:p>
              <a:pPr algn="ctr" fontAlgn="base"/>
              <a:r>
                <a:rPr lang="en-US" b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*</a:t>
              </a:r>
              <a:endParaRPr lang="en-US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2">
              <a:extLst>
                <a:ext uri="{FF2B5EF4-FFF2-40B4-BE49-F238E27FC236}">
                  <a16:creationId xmlns:a16="http://schemas.microsoft.com/office/drawing/2014/main" id="{1F0D9F30-7442-42C3-B73D-92B8835AECA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391663" y="1143376"/>
              <a:ext cx="521869" cy="371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anchor="ctr" anchorCtr="0">
              <a:noAutofit/>
            </a:bodyPr>
            <a:lstStyle/>
            <a:p>
              <a:pPr algn="ctr" fontAlgn="base"/>
              <a:r>
                <a:rPr lang="en-US" b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*</a:t>
              </a:r>
              <a:endParaRPr lang="en-US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" name="Group 16">
            <a:extLst>
              <a:ext uri="{FF2B5EF4-FFF2-40B4-BE49-F238E27FC236}">
                <a16:creationId xmlns:a16="http://schemas.microsoft.com/office/drawing/2014/main" id="{1A1247CC-C0A9-43E4-B424-1A8039673CF3}"/>
              </a:ext>
            </a:extLst>
          </p:cNvPr>
          <p:cNvGrpSpPr/>
          <p:nvPr/>
        </p:nvGrpSpPr>
        <p:grpSpPr>
          <a:xfrm>
            <a:off x="1815619" y="6979042"/>
            <a:ext cx="4184850" cy="1592089"/>
            <a:chOff x="397573" y="2742021"/>
            <a:chExt cx="4184850" cy="1592089"/>
          </a:xfrm>
        </p:grpSpPr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A0350669-E2D6-4A5E-89B7-B4F65C3F63A5}"/>
                </a:ext>
              </a:extLst>
            </p:cNvPr>
            <p:cNvGrpSpPr/>
            <p:nvPr/>
          </p:nvGrpSpPr>
          <p:grpSpPr>
            <a:xfrm>
              <a:off x="397573" y="2742021"/>
              <a:ext cx="4184850" cy="1592089"/>
              <a:chOff x="1041823" y="4189510"/>
              <a:chExt cx="4184850" cy="1592089"/>
            </a:xfrm>
          </p:grpSpPr>
          <p:pic>
            <p:nvPicPr>
              <p:cNvPr id="21" name="Picture 20">
                <a:extLst>
                  <a:ext uri="{FF2B5EF4-FFF2-40B4-BE49-F238E27FC236}">
                    <a16:creationId xmlns:a16="http://schemas.microsoft.com/office/drawing/2014/main" id="{174AFC42-81D8-4FB8-8A87-1147E50CC60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888" t="49057" r="30380" b="39109"/>
              <a:stretch/>
            </p:blipFill>
            <p:spPr>
              <a:xfrm>
                <a:off x="1046292" y="4810242"/>
                <a:ext cx="2852377" cy="42147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793FE1AA-7EE0-4501-8A05-17F2F867EAAD}"/>
                  </a:ext>
                </a:extLst>
              </p:cNvPr>
              <p:cNvSpPr txBox="1"/>
              <p:nvPr/>
            </p:nvSpPr>
            <p:spPr>
              <a:xfrm rot="16200000">
                <a:off x="1056832" y="4389754"/>
                <a:ext cx="67748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V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8FC46753-B1D6-4C8D-8767-240319CCCFFD}"/>
                  </a:ext>
                </a:extLst>
              </p:cNvPr>
              <p:cNvSpPr txBox="1"/>
              <p:nvPr/>
            </p:nvSpPr>
            <p:spPr>
              <a:xfrm>
                <a:off x="3844501" y="4892717"/>
                <a:ext cx="135497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TARD10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E30C95F9-79DE-4FA5-A3B1-E817F7FF48B7}"/>
                  </a:ext>
                </a:extLst>
              </p:cNvPr>
              <p:cNvSpPr txBox="1"/>
              <p:nvPr/>
            </p:nvSpPr>
            <p:spPr>
              <a:xfrm rot="16200000">
                <a:off x="1525836" y="4389754"/>
                <a:ext cx="67748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EtOH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30D1540C-43F8-4F01-B831-E6409681FADF}"/>
                  </a:ext>
                </a:extLst>
              </p:cNvPr>
              <p:cNvSpPr txBox="1"/>
              <p:nvPr/>
            </p:nvSpPr>
            <p:spPr>
              <a:xfrm rot="16200000">
                <a:off x="1943796" y="4389754"/>
                <a:ext cx="67748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65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D8598351-204D-4A10-8362-AD9CAC02B0E2}"/>
                  </a:ext>
                </a:extLst>
              </p:cNvPr>
              <p:cNvSpPr txBox="1"/>
              <p:nvPr/>
            </p:nvSpPr>
            <p:spPr>
              <a:xfrm rot="16200000">
                <a:off x="2380518" y="4389754"/>
                <a:ext cx="67748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-</a:t>
                </a:r>
                <a:r>
                  <a:rPr lang="en-US" sz="12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yc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7A8DB5C0-2B2F-43DA-9898-ACAEC99BF630}"/>
                  </a:ext>
                </a:extLst>
              </p:cNvPr>
              <p:cNvSpPr txBox="1"/>
              <p:nvPr/>
            </p:nvSpPr>
            <p:spPr>
              <a:xfrm rot="16200000">
                <a:off x="2804910" y="4389754"/>
                <a:ext cx="67748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-</a:t>
                </a:r>
                <a:r>
                  <a:rPr lang="en-US" sz="12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os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4B64B70C-1DE8-48E4-B82F-D47C6D8AD898}"/>
                  </a:ext>
                </a:extLst>
              </p:cNvPr>
              <p:cNvSpPr txBox="1"/>
              <p:nvPr/>
            </p:nvSpPr>
            <p:spPr>
              <a:xfrm rot="16200000">
                <a:off x="3280911" y="4389754"/>
                <a:ext cx="67748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-Jun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C0F9CF01-33FC-4A3B-B357-9706D24A1432}"/>
                  </a:ext>
                </a:extLst>
              </p:cNvPr>
              <p:cNvSpPr txBox="1"/>
              <p:nvPr/>
            </p:nvSpPr>
            <p:spPr>
              <a:xfrm>
                <a:off x="3871699" y="5455197"/>
                <a:ext cx="135497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CTIN</a:t>
                </a:r>
              </a:p>
            </p:txBody>
          </p:sp>
          <p:pic>
            <p:nvPicPr>
              <p:cNvPr id="30" name="Picture 29">
                <a:extLst>
                  <a:ext uri="{FF2B5EF4-FFF2-40B4-BE49-F238E27FC236}">
                    <a16:creationId xmlns:a16="http://schemas.microsoft.com/office/drawing/2014/main" id="{653C4D49-69DE-4333-81E3-96D17A98188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447" t="39542" r="24447" b="49864"/>
              <a:stretch/>
            </p:blipFill>
            <p:spPr>
              <a:xfrm>
                <a:off x="1041823" y="5409753"/>
                <a:ext cx="2852377" cy="371846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C6570E86-FEA2-4DDE-AEDE-53887011A5BB}"/>
                </a:ext>
              </a:extLst>
            </p:cNvPr>
            <p:cNvSpPr txBox="1"/>
            <p:nvPr/>
          </p:nvSpPr>
          <p:spPr>
            <a:xfrm>
              <a:off x="434608" y="3757133"/>
              <a:ext cx="356926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1.0±0.1   2</a:t>
              </a:r>
              <a:r>
                <a:rPr lang="en-US" sz="9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0</a:t>
              </a:r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±0.5* 1.8±0.2*1.6±0.1*1.6±0.2* 1.3±0.1* </a:t>
              </a:r>
            </a:p>
          </p:txBody>
        </p:sp>
      </p:grpSp>
      <p:sp>
        <p:nvSpPr>
          <p:cNvPr id="39" name="Text Box 2">
            <a:extLst>
              <a:ext uri="{FF2B5EF4-FFF2-40B4-BE49-F238E27FC236}">
                <a16:creationId xmlns:a16="http://schemas.microsoft.com/office/drawing/2014/main" id="{F0B1612D-FD16-4A04-8EDC-CCCB26557FE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277" y="80607"/>
            <a:ext cx="515938" cy="341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.       </a:t>
            </a:r>
            <a:endParaRPr lang="en-US" altLang="en-US" dirty="0">
              <a:latin typeface="Arial" panose="020B0604020202020204" pitchFamily="34" charset="0"/>
            </a:endParaRPr>
          </a:p>
        </p:txBody>
      </p:sp>
      <p:sp>
        <p:nvSpPr>
          <p:cNvPr id="40" name="Text Box 2">
            <a:extLst>
              <a:ext uri="{FF2B5EF4-FFF2-40B4-BE49-F238E27FC236}">
                <a16:creationId xmlns:a16="http://schemas.microsoft.com/office/drawing/2014/main" id="{5F2F86B5-A702-4457-B632-0361A2EA7FC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277" y="4321119"/>
            <a:ext cx="515938" cy="341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.       </a:t>
            </a:r>
            <a:endParaRPr lang="en-US" altLang="en-US" dirty="0">
              <a:latin typeface="Arial" panose="020B0604020202020204" pitchFamily="34" charset="0"/>
            </a:endParaRPr>
          </a:p>
        </p:txBody>
      </p:sp>
      <p:sp>
        <p:nvSpPr>
          <p:cNvPr id="42" name="Text Box 2">
            <a:extLst>
              <a:ext uri="{FF2B5EF4-FFF2-40B4-BE49-F238E27FC236}">
                <a16:creationId xmlns:a16="http://schemas.microsoft.com/office/drawing/2014/main" id="{CA69F779-5CAD-4416-99B9-D5C68E18658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98321" y="4321119"/>
            <a:ext cx="515938" cy="341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.       </a:t>
            </a:r>
            <a:endParaRPr lang="en-US" altLang="en-US" dirty="0">
              <a:latin typeface="Arial" panose="020B0604020202020204" pitchFamily="34" charset="0"/>
            </a:endParaRPr>
          </a:p>
        </p:txBody>
      </p:sp>
      <p:sp>
        <p:nvSpPr>
          <p:cNvPr id="43" name="Text Box 2">
            <a:extLst>
              <a:ext uri="{FF2B5EF4-FFF2-40B4-BE49-F238E27FC236}">
                <a16:creationId xmlns:a16="http://schemas.microsoft.com/office/drawing/2014/main" id="{E5E10C0C-1EB2-4F0D-920C-F8CF5725B00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277" y="6978682"/>
            <a:ext cx="515938" cy="341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.       </a:t>
            </a:r>
            <a:endParaRPr lang="en-US" altLang="en-US" dirty="0">
              <a:latin typeface="Arial" panose="020B0604020202020204" pitchFamily="34" charset="0"/>
            </a:endParaRPr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8D7540E8-AE6D-4D54-ABFF-CC580958FEF8}"/>
              </a:ext>
            </a:extLst>
          </p:cNvPr>
          <p:cNvGrpSpPr/>
          <p:nvPr/>
        </p:nvGrpSpPr>
        <p:grpSpPr>
          <a:xfrm>
            <a:off x="392146" y="21497"/>
            <a:ext cx="6278245" cy="4505270"/>
            <a:chOff x="369842" y="77252"/>
            <a:chExt cx="6278245" cy="4505270"/>
          </a:xfrm>
        </p:grpSpPr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21D40916-4E58-4183-8188-34EDB58DA064}"/>
                </a:ext>
              </a:extLst>
            </p:cNvPr>
            <p:cNvSpPr/>
            <p:nvPr/>
          </p:nvSpPr>
          <p:spPr>
            <a:xfrm>
              <a:off x="369842" y="493304"/>
              <a:ext cx="6222382" cy="365914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agcagtagaaatttaagaagttgccatgccagc</a:t>
              </a:r>
              <a:r>
                <a:rPr lang="en-US" sz="1200" u="sng" dirty="0">
                  <a:latin typeface="Arial" panose="020B0604020202020204" pitchFamily="34" charset="0"/>
                  <a:cs typeface="Arial" panose="020B0604020202020204" pitchFamily="34" charset="0"/>
                </a:rPr>
                <a:t>tgacagc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gagccctgaggtaggcaacgtttgtttccttaaccttaaccttaaggtccatcgtagttgataaaaaggcatctggccaggcctgatggctcacgcctataatcccagcactttgggagggtgaggcgggaggccagcagttctggggccactgcactccagcc</a:t>
              </a:r>
              <a:r>
                <a:rPr lang="en-US" sz="1200" u="sng" dirty="0">
                  <a:latin typeface="Arial" panose="020B0604020202020204" pitchFamily="34" charset="0"/>
                  <a:cs typeface="Arial" panose="020B0604020202020204" pitchFamily="34" charset="0"/>
                </a:rPr>
                <a:t>tgacaga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agagaccctgtctcaaaaaataaataaataaaaaagataaaggggcatttgtcttgatcgctcagatcacacaactaataagtagcattctttctaaaagccgcaacaatgctactcctctcttataagagctactgtgtaactcctgcccaactcaaacccacaggcccaggctcagaacacttggctccattgcttcactgtttccctgctagcacgaaccccccaaactccatctcccaacatgccgcgggccccctt</a:t>
              </a:r>
              <a:r>
                <a:rPr lang="en-US" sz="1200" u="sng" dirty="0">
                  <a:latin typeface="Arial" panose="020B0604020202020204" pitchFamily="34" charset="0"/>
                  <a:cs typeface="Arial" panose="020B0604020202020204" pitchFamily="34" charset="0"/>
                </a:rPr>
                <a:t>tctgtcagcctgactct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gagctcctgagaaatgtagtttttccagcggcccagccccagaaaggtcctagccaagaactacagttcccatgtggcaatgcgcgcgccattccggtggaattcaccgcggtctccagtttgccatgatggatgccagaacctg</a:t>
              </a:r>
              <a:r>
                <a:rPr lang="en-US" sz="1200" u="sng" dirty="0">
                  <a:latin typeface="Arial" panose="020B0604020202020204" pitchFamily="34" charset="0"/>
                  <a:cs typeface="Arial" panose="020B0604020202020204" pitchFamily="34" charset="0"/>
                </a:rPr>
                <a:t>cacgtg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gggcttgg</a:t>
              </a:r>
              <a:r>
                <a:rPr lang="en-US" sz="1200" u="sng" dirty="0">
                  <a:latin typeface="Arial" panose="020B0604020202020204" pitchFamily="34" charset="0"/>
                  <a:cs typeface="Arial" panose="020B0604020202020204" pitchFamily="34" charset="0"/>
                </a:rPr>
                <a:t>tgacgcg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sz="1200" u="sng" dirty="0">
                  <a:latin typeface="Arial" panose="020B0604020202020204" pitchFamily="34" charset="0"/>
                  <a:cs typeface="Arial" panose="020B0604020202020204" pitchFamily="34" charset="0"/>
                </a:rPr>
                <a:t>tgactga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gatgctggagtcc</a:t>
              </a:r>
              <a:r>
                <a:rPr lang="en-US" sz="1200" u="sng" dirty="0">
                  <a:latin typeface="Arial" panose="020B0604020202020204" pitchFamily="34" charset="0"/>
                  <a:cs typeface="Arial" panose="020B0604020202020204" pitchFamily="34" charset="0"/>
                </a:rPr>
                <a:t>ccggtca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gaaggacgatgccgagcgcgccgtattttctcctgcctctcctcagatcgccgccgttgttgggctgtggagacgtctcaaccaaagtggagccgacagaggccccgggagccgtgg</a:t>
              </a:r>
              <a:r>
                <a:rPr lang="en-US" sz="1200" u="sng" dirty="0">
                  <a:latin typeface="Arial" panose="020B0604020202020204" pitchFamily="34" charset="0"/>
                  <a:cs typeface="Arial" panose="020B0604020202020204" pitchFamily="34" charset="0"/>
                </a:rPr>
                <a:t>tgacaga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gcggccacaaccactagggggcgggaggcagagcggcccctagtccgcccctagtccgggacctctgggcggtcccggg</a:t>
              </a:r>
              <a:r>
                <a:rPr lang="en-US" sz="1200" u="sng" dirty="0">
                  <a:latin typeface="Arial" panose="020B0604020202020204" pitchFamily="34" charset="0"/>
                  <a:cs typeface="Arial" panose="020B0604020202020204" pitchFamily="34" charset="0"/>
                </a:rPr>
                <a:t>cgggaagcgc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cgcgcaaacgcggg</a:t>
              </a:r>
              <a:r>
                <a:rPr lang="en-US" sz="1200" u="sng" dirty="0">
                  <a:latin typeface="Arial" panose="020B0604020202020204" pitchFamily="34" charset="0"/>
                  <a:cs typeface="Arial" panose="020B0604020202020204" pitchFamily="34" charset="0"/>
                </a:rPr>
                <a:t>gcttcgcggccg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tgtaaacaccaaagagcgcctgcgcaagccgagagtctcgggatcga</a:t>
              </a:r>
              <a:r>
                <a:rPr lang="en-US" sz="1200" u="sng" dirty="0">
                  <a:latin typeface="Arial" panose="020B0604020202020204" pitchFamily="34" charset="0"/>
                  <a:cs typeface="Arial" panose="020B0604020202020204" pitchFamily="34" charset="0"/>
                </a:rPr>
                <a:t>cacgtg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ggggcgcctgagcgaagat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accgtaataaatagtaacctaacggtccagt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C09A7848-2C42-42F7-9722-101D0C46D987}"/>
                </a:ext>
              </a:extLst>
            </p:cNvPr>
            <p:cNvSpPr txBox="1"/>
            <p:nvPr/>
          </p:nvSpPr>
          <p:spPr>
            <a:xfrm>
              <a:off x="1665648" y="4120857"/>
              <a:ext cx="327414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ranscriptional starting site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3" name="Group 32">
              <a:extLst>
                <a:ext uri="{FF2B5EF4-FFF2-40B4-BE49-F238E27FC236}">
                  <a16:creationId xmlns:a16="http://schemas.microsoft.com/office/drawing/2014/main" id="{71543661-74B6-4477-858F-7FC72F6D9168}"/>
                </a:ext>
              </a:extLst>
            </p:cNvPr>
            <p:cNvGrpSpPr/>
            <p:nvPr/>
          </p:nvGrpSpPr>
          <p:grpSpPr>
            <a:xfrm>
              <a:off x="2104000" y="4057711"/>
              <a:ext cx="2462981" cy="86157"/>
              <a:chOff x="2072328" y="3325761"/>
              <a:chExt cx="2462981" cy="148859"/>
            </a:xfrm>
          </p:grpSpPr>
          <p:cxnSp>
            <p:nvCxnSpPr>
              <p:cNvPr id="34" name="Straight Arrow Connector 33">
                <a:extLst>
                  <a:ext uri="{FF2B5EF4-FFF2-40B4-BE49-F238E27FC236}">
                    <a16:creationId xmlns:a16="http://schemas.microsoft.com/office/drawing/2014/main" id="{61AD14B2-FE5B-4ABD-8E0C-AC0B84A9EB76}"/>
                  </a:ext>
                </a:extLst>
              </p:cNvPr>
              <p:cNvCxnSpPr/>
              <p:nvPr/>
            </p:nvCxnSpPr>
            <p:spPr>
              <a:xfrm>
                <a:off x="2072328" y="3474620"/>
                <a:ext cx="2462981" cy="0"/>
              </a:xfrm>
              <a:prstGeom prst="straightConnector1">
                <a:avLst/>
              </a:prstGeom>
              <a:ln w="28575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5" name="Straight Connector 34">
                <a:extLst>
                  <a:ext uri="{FF2B5EF4-FFF2-40B4-BE49-F238E27FC236}">
                    <a16:creationId xmlns:a16="http://schemas.microsoft.com/office/drawing/2014/main" id="{74FDB286-8DF5-498F-A20B-0CB77617B677}"/>
                  </a:ext>
                </a:extLst>
              </p:cNvPr>
              <p:cNvCxnSpPr/>
              <p:nvPr/>
            </p:nvCxnSpPr>
            <p:spPr>
              <a:xfrm flipV="1">
                <a:off x="2090853" y="3325761"/>
                <a:ext cx="0" cy="148859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7" name="Rectangle 26">
              <a:extLst>
                <a:ext uri="{FF2B5EF4-FFF2-40B4-BE49-F238E27FC236}">
                  <a16:creationId xmlns:a16="http://schemas.microsoft.com/office/drawing/2014/main" id="{DA2AA409-B4E5-4DB4-AA9A-578559610E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9842" y="77252"/>
              <a:ext cx="3879901" cy="46166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US" alt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1200" b="1" dirty="0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STARD10</a:t>
              </a:r>
              <a:r>
                <a:rPr lang="en-US" altLang="en-US" sz="1200" dirty="0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 </a:t>
              </a:r>
              <a:r>
                <a:rPr lang="en-US" altLang="en-US" sz="1200" b="1" dirty="0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promoter</a:t>
              </a:r>
              <a:r>
                <a:rPr lang="en-US" altLang="en-US" sz="1200" dirty="0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 (chr11:72791657-72795657)</a:t>
              </a:r>
              <a:endParaRPr lang="en-US" altLang="en-US" dirty="0">
                <a:latin typeface="Arial" panose="020B0604020202020204" pitchFamily="34" charset="0"/>
              </a:endParaRP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70D2A6B9-687D-4131-8913-955DDE17232F}"/>
                </a:ext>
              </a:extLst>
            </p:cNvPr>
            <p:cNvSpPr txBox="1"/>
            <p:nvPr/>
          </p:nvSpPr>
          <p:spPr>
            <a:xfrm>
              <a:off x="5592188" y="3166154"/>
              <a:ext cx="6756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p65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0F14DC7D-1567-47A9-B3E1-799BC258EA07}"/>
                </a:ext>
              </a:extLst>
            </p:cNvPr>
            <p:cNvSpPr txBox="1"/>
            <p:nvPr/>
          </p:nvSpPr>
          <p:spPr>
            <a:xfrm>
              <a:off x="1758640" y="3443940"/>
              <a:ext cx="6756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p65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29F81672-2492-4884-A2F3-3D6DF2D3AE7A}"/>
                </a:ext>
              </a:extLst>
            </p:cNvPr>
            <p:cNvSpPr txBox="1"/>
            <p:nvPr/>
          </p:nvSpPr>
          <p:spPr>
            <a:xfrm>
              <a:off x="5971792" y="3446747"/>
              <a:ext cx="6756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-</a:t>
              </a:r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yc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D8AB7B3D-1C68-489E-A4E7-483984C8FACC}"/>
                </a:ext>
              </a:extLst>
            </p:cNvPr>
            <p:cNvSpPr txBox="1"/>
            <p:nvPr/>
          </p:nvSpPr>
          <p:spPr>
            <a:xfrm>
              <a:off x="4647370" y="2328088"/>
              <a:ext cx="6756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-</a:t>
              </a:r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yc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B2747C3E-4760-4B3F-96E5-C7C457B6A0E3}"/>
                </a:ext>
              </a:extLst>
            </p:cNvPr>
            <p:cNvSpPr txBox="1"/>
            <p:nvPr/>
          </p:nvSpPr>
          <p:spPr>
            <a:xfrm>
              <a:off x="5481996" y="1806315"/>
              <a:ext cx="6756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-</a:t>
              </a:r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Fos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5018A439-6DC3-40A4-ABF2-5E5D5AD54237}"/>
                </a:ext>
              </a:extLst>
            </p:cNvPr>
            <p:cNvSpPr txBox="1"/>
            <p:nvPr/>
          </p:nvSpPr>
          <p:spPr>
            <a:xfrm>
              <a:off x="369842" y="2636484"/>
              <a:ext cx="6756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-Jun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AA17DFF2-8600-4625-898B-CFCC2045211C}"/>
                </a:ext>
              </a:extLst>
            </p:cNvPr>
            <p:cNvSpPr txBox="1"/>
            <p:nvPr/>
          </p:nvSpPr>
          <p:spPr>
            <a:xfrm>
              <a:off x="1737669" y="2637041"/>
              <a:ext cx="6756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-Jun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05F3CBDB-A7EC-42E3-8693-322DADC51647}"/>
                </a:ext>
              </a:extLst>
            </p:cNvPr>
            <p:cNvSpPr txBox="1"/>
            <p:nvPr/>
          </p:nvSpPr>
          <p:spPr>
            <a:xfrm>
              <a:off x="4986895" y="1803855"/>
              <a:ext cx="6756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-Jun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2EB6F17A-4748-4088-AFA5-ECEB3CF04E9C}"/>
                </a:ext>
              </a:extLst>
            </p:cNvPr>
            <p:cNvSpPr txBox="1"/>
            <p:nvPr/>
          </p:nvSpPr>
          <p:spPr>
            <a:xfrm>
              <a:off x="4897838" y="2893332"/>
              <a:ext cx="6756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-Jun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53ECC85B-2D21-459C-AF94-9C3023808DA8}"/>
                </a:ext>
              </a:extLst>
            </p:cNvPr>
            <p:cNvSpPr txBox="1"/>
            <p:nvPr/>
          </p:nvSpPr>
          <p:spPr>
            <a:xfrm>
              <a:off x="3479582" y="980313"/>
              <a:ext cx="6756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-Jun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08159E92-EA2A-4E7E-AC70-C3B8A7CB7A51}"/>
                </a:ext>
              </a:extLst>
            </p:cNvPr>
            <p:cNvSpPr txBox="1"/>
            <p:nvPr/>
          </p:nvSpPr>
          <p:spPr>
            <a:xfrm>
              <a:off x="2927322" y="431772"/>
              <a:ext cx="6756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-Jun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6D67270D-BB88-42E3-9999-EB246080CD97}"/>
                </a:ext>
              </a:extLst>
            </p:cNvPr>
            <p:cNvSpPr txBox="1"/>
            <p:nvPr/>
          </p:nvSpPr>
          <p:spPr>
            <a:xfrm>
              <a:off x="5687600" y="2352499"/>
              <a:ext cx="6756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-Jun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6158337B-46F5-4BA2-964D-CB0957A538FC}"/>
                </a:ext>
              </a:extLst>
            </p:cNvPr>
            <p:cNvSpPr txBox="1"/>
            <p:nvPr/>
          </p:nvSpPr>
          <p:spPr>
            <a:xfrm>
              <a:off x="5972475" y="3164943"/>
              <a:ext cx="6756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-Jun</a:t>
              </a:r>
            </a:p>
          </p:txBody>
        </p: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E67047A0-E4FC-4546-8A44-439C23F90979}"/>
              </a:ext>
            </a:extLst>
          </p:cNvPr>
          <p:cNvGrpSpPr/>
          <p:nvPr/>
        </p:nvGrpSpPr>
        <p:grpSpPr>
          <a:xfrm>
            <a:off x="3599055" y="4889731"/>
            <a:ext cx="3008061" cy="2142327"/>
            <a:chOff x="3599053" y="4878578"/>
            <a:chExt cx="3008061" cy="2142327"/>
          </a:xfrm>
        </p:grpSpPr>
        <p:graphicFrame>
          <p:nvGraphicFramePr>
            <p:cNvPr id="60" name="Chart 59"/>
            <p:cNvGraphicFramePr>
              <a:graphicFrameLocks/>
            </p:cNvGraphicFramePr>
            <p:nvPr>
              <p:extLst/>
            </p:nvPr>
          </p:nvGraphicFramePr>
          <p:xfrm>
            <a:off x="4034131" y="5000205"/>
            <a:ext cx="2572983" cy="20207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61" name="TextBox 2"/>
            <p:cNvSpPr txBox="1">
              <a:spLocks noChangeArrowheads="1"/>
            </p:cNvSpPr>
            <p:nvPr/>
          </p:nvSpPr>
          <p:spPr bwMode="auto">
            <a:xfrm rot="16200000">
              <a:off x="2852922" y="5624709"/>
              <a:ext cx="1850264" cy="3580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noAutofit/>
            </a:bodyPr>
            <a:lstStyle/>
            <a:p>
              <a:pPr algn="ctr" fontAlgn="base"/>
              <a:r>
                <a:rPr lang="en-US" sz="1200" b="1" i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STARD10</a:t>
              </a:r>
              <a:r>
                <a:rPr lang="en-US" sz="1200" b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 mRNA levels</a:t>
              </a:r>
              <a:endPara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  <a:p>
              <a:pPr algn="ctr" fontAlgn="base"/>
              <a:r>
                <a:rPr lang="en-US" sz="1200" b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(relative to EV)</a:t>
              </a:r>
              <a:endPara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51" name="TextBox 2">
              <a:extLst>
                <a:ext uri="{FF2B5EF4-FFF2-40B4-BE49-F238E27FC236}">
                  <a16:creationId xmlns:a16="http://schemas.microsoft.com/office/drawing/2014/main" id="{2340F37F-024A-488C-AC1E-BA5BCD69FFC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784941" y="5051606"/>
              <a:ext cx="331999" cy="2810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anchor="ctr" anchorCtr="0">
              <a:noAutofit/>
            </a:bodyPr>
            <a:lstStyle/>
            <a:p>
              <a:pPr algn="ctr" fontAlgn="base"/>
              <a:r>
                <a:rPr lang="en-US" b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*</a:t>
              </a:r>
              <a:endParaRPr lang="en-US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58" name="TextBox 2">
              <a:extLst>
                <a:ext uri="{FF2B5EF4-FFF2-40B4-BE49-F238E27FC236}">
                  <a16:creationId xmlns:a16="http://schemas.microsoft.com/office/drawing/2014/main" id="{E6A9AFAD-A636-47DC-AA58-B1FCFD44DBB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124658" y="4991554"/>
              <a:ext cx="331999" cy="2810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anchor="ctr" anchorCtr="0">
              <a:noAutofit/>
            </a:bodyPr>
            <a:lstStyle/>
            <a:p>
              <a:pPr algn="ctr" fontAlgn="base"/>
              <a:r>
                <a:rPr lang="en-US" b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*</a:t>
              </a:r>
              <a:endParaRPr lang="en-US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59" name="TextBox 2">
              <a:extLst>
                <a:ext uri="{FF2B5EF4-FFF2-40B4-BE49-F238E27FC236}">
                  <a16:creationId xmlns:a16="http://schemas.microsoft.com/office/drawing/2014/main" id="{EE5D2C69-90BD-4F41-816E-3235FBD647E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466625" y="5032444"/>
              <a:ext cx="331999" cy="2810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anchor="ctr" anchorCtr="0">
              <a:noAutofit/>
            </a:bodyPr>
            <a:lstStyle/>
            <a:p>
              <a:pPr algn="ctr" fontAlgn="base"/>
              <a:r>
                <a:rPr lang="en-US" b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*</a:t>
              </a:r>
              <a:endParaRPr lang="en-US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62" name="TextBox 2">
              <a:extLst>
                <a:ext uri="{FF2B5EF4-FFF2-40B4-BE49-F238E27FC236}">
                  <a16:creationId xmlns:a16="http://schemas.microsoft.com/office/drawing/2014/main" id="{F7D4814A-D5A9-45F5-A084-8D27EEDEC35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797441" y="5474770"/>
              <a:ext cx="331999" cy="2810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anchor="ctr" anchorCtr="0">
              <a:noAutofit/>
            </a:bodyPr>
            <a:lstStyle/>
            <a:p>
              <a:pPr algn="ctr" fontAlgn="base"/>
              <a:r>
                <a:rPr lang="en-US" b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*</a:t>
              </a:r>
              <a:endParaRPr lang="en-US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4068992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74</Words>
  <Application>Microsoft Office PowerPoint</Application>
  <PresentationFormat>On-screen Show (4:3)</PresentationFormat>
  <Paragraphs>4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masi, Maria Lauda</dc:creator>
  <cp:lastModifiedBy>Tomasi, Maria Lauda</cp:lastModifiedBy>
  <cp:revision>2</cp:revision>
  <dcterms:created xsi:type="dcterms:W3CDTF">2018-10-11T23:00:29Z</dcterms:created>
  <dcterms:modified xsi:type="dcterms:W3CDTF">2018-10-12T22:24:27Z</dcterms:modified>
</cp:coreProperties>
</file>